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charts/style2.xml" ContentType="application/vnd.ms-office.chartstyl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olors4.xml" ContentType="application/vnd.ms-office.chartcolorstyle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charts/colors2.xml" ContentType="application/vnd.ms-office.chartcolorstyle+xml"/>
  <Override PartName="/ppt/charts/colors3.xml" ContentType="application/vnd.ms-office.chartcolorstyl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3.xml" ContentType="application/vnd.ms-office.chartstyle+xml"/>
  <Override PartName="/ppt/charts/style4.xml" ContentType="application/vnd.ms-office.chartstyle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60" r:id="rId3"/>
    <p:sldId id="261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1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customXml" Target="../customXml/item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zengga\Documents\LightCycler%2096\data\2017\EBT%20wavelengh%20test\9-12-2017%20EBT%20wavelengh%20test%20resul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zengga\Documents\LightCycler%2096\data\2017\EBT%20wavelengh%20test\9-12-2017%20EBT%20wavelengh%20test%20resul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zengga\Documents\LightCycler%2096\data\2017\EBT%20wavelengh%20test\9-12-2017%20EBT%20wavelengh%20test%20resul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zengga\Documents\LightCycler%2096\data\2017\EBT%20wavelengh%20test\9-12-2017%20EBT%20wavelengh%20test%20resul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475nm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All three sets'!$F$3:$F$4</c:f>
              <c:strCache>
                <c:ptCount val="2"/>
                <c:pt idx="0">
                  <c:v>475nm average</c:v>
                </c:pt>
                <c:pt idx="1">
                  <c:v>Positiv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F$19:$F$28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1558670158629999</c:v>
                  </c:pt>
                  <c:pt idx="2">
                    <c:v>2.6553608217929101E-2</c:v>
                  </c:pt>
                  <c:pt idx="3">
                    <c:v>2.6702231951265899E-2</c:v>
                  </c:pt>
                  <c:pt idx="4">
                    <c:v>8.5021240877792406E-2</c:v>
                  </c:pt>
                  <c:pt idx="5">
                    <c:v>0.260675511121226</c:v>
                  </c:pt>
                  <c:pt idx="6">
                    <c:v>1.1876217071368871</c:v>
                  </c:pt>
                  <c:pt idx="7">
                    <c:v>0.52552203209677995</c:v>
                  </c:pt>
                  <c:pt idx="8">
                    <c:v>0.72860751580776495</c:v>
                  </c:pt>
                  <c:pt idx="9">
                    <c:v>0.42635917360412801</c:v>
                  </c:pt>
                </c:numCache>
              </c:numRef>
            </c:plus>
            <c:minus>
              <c:numRef>
                <c:f>'All three sets'!$F$19:$F$28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1558670158629999</c:v>
                  </c:pt>
                  <c:pt idx="2">
                    <c:v>2.6553608217929101E-2</c:v>
                  </c:pt>
                  <c:pt idx="3">
                    <c:v>2.6702231951265899E-2</c:v>
                  </c:pt>
                  <c:pt idx="4">
                    <c:v>8.5021240877792406E-2</c:v>
                  </c:pt>
                  <c:pt idx="5">
                    <c:v>0.260675511121226</c:v>
                  </c:pt>
                  <c:pt idx="6">
                    <c:v>1.1876217071368871</c:v>
                  </c:pt>
                  <c:pt idx="7">
                    <c:v>0.52552203209677995</c:v>
                  </c:pt>
                  <c:pt idx="8">
                    <c:v>0.72860751580776495</c:v>
                  </c:pt>
                  <c:pt idx="9">
                    <c:v>0.426359173604128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E$5:$E$14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F$5:$F$14</c:f>
              <c:numCache>
                <c:formatCode>General</c:formatCode>
                <c:ptCount val="10"/>
                <c:pt idx="0">
                  <c:v>1</c:v>
                </c:pt>
                <c:pt idx="1">
                  <c:v>1.029950669485554</c:v>
                </c:pt>
                <c:pt idx="2">
                  <c:v>1.0306553911205081</c:v>
                </c:pt>
                <c:pt idx="3">
                  <c:v>0.99242424242424199</c:v>
                </c:pt>
                <c:pt idx="4">
                  <c:v>2.13002114164905</c:v>
                </c:pt>
                <c:pt idx="5">
                  <c:v>2.5991895701198029</c:v>
                </c:pt>
                <c:pt idx="6">
                  <c:v>3.3518322762508799</c:v>
                </c:pt>
                <c:pt idx="7">
                  <c:v>3.321353065539113</c:v>
                </c:pt>
                <c:pt idx="8">
                  <c:v>3.6097603946441161</c:v>
                </c:pt>
                <c:pt idx="9">
                  <c:v>3.7669133192389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52-4BEE-B043-BAE5A4137876}"/>
            </c:ext>
          </c:extLst>
        </c:ser>
        <c:ser>
          <c:idx val="1"/>
          <c:order val="1"/>
          <c:tx>
            <c:strRef>
              <c:f>'All three sets'!$G$3:$G$4</c:f>
              <c:strCache>
                <c:ptCount val="2"/>
                <c:pt idx="0">
                  <c:v>475nm average</c:v>
                </c:pt>
                <c:pt idx="1">
                  <c:v>negativ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G$19:$G$28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85125196194415</c:v>
                  </c:pt>
                  <c:pt idx="2">
                    <c:v>0.15544012421112599</c:v>
                  </c:pt>
                  <c:pt idx="3">
                    <c:v>0.109902842341022</c:v>
                  </c:pt>
                  <c:pt idx="4">
                    <c:v>6.2685456553962099E-2</c:v>
                  </c:pt>
                  <c:pt idx="5">
                    <c:v>0.25215177873856998</c:v>
                  </c:pt>
                  <c:pt idx="6">
                    <c:v>0.192906959225039</c:v>
                  </c:pt>
                  <c:pt idx="7">
                    <c:v>0.16279074046807401</c:v>
                  </c:pt>
                  <c:pt idx="8">
                    <c:v>4.5711356550605202E-2</c:v>
                  </c:pt>
                  <c:pt idx="9">
                    <c:v>0.25080795000953798</c:v>
                  </c:pt>
                </c:numCache>
              </c:numRef>
            </c:plus>
            <c:minus>
              <c:numRef>
                <c:f>'All three sets'!$G$19:$G$28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85125196194415</c:v>
                  </c:pt>
                  <c:pt idx="2">
                    <c:v>0.15544012421112599</c:v>
                  </c:pt>
                  <c:pt idx="3">
                    <c:v>0.109902842341022</c:v>
                  </c:pt>
                  <c:pt idx="4">
                    <c:v>6.2685456553962099E-2</c:v>
                  </c:pt>
                  <c:pt idx="5">
                    <c:v>0.25215177873856998</c:v>
                  </c:pt>
                  <c:pt idx="6">
                    <c:v>0.192906959225039</c:v>
                  </c:pt>
                  <c:pt idx="7">
                    <c:v>0.16279074046807401</c:v>
                  </c:pt>
                  <c:pt idx="8">
                    <c:v>4.5711356550605202E-2</c:v>
                  </c:pt>
                  <c:pt idx="9">
                    <c:v>0.250807950009537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E$5:$E$14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G$5:$G$14</c:f>
              <c:numCache>
                <c:formatCode>General</c:formatCode>
                <c:ptCount val="10"/>
                <c:pt idx="0">
                  <c:v>1</c:v>
                </c:pt>
                <c:pt idx="1">
                  <c:v>1.0721983330678979</c:v>
                </c:pt>
                <c:pt idx="2">
                  <c:v>1.137649307214524</c:v>
                </c:pt>
                <c:pt idx="3">
                  <c:v>1.0160322769018419</c:v>
                </c:pt>
                <c:pt idx="4">
                  <c:v>1.089791368052238</c:v>
                </c:pt>
                <c:pt idx="5">
                  <c:v>1.2526729309338009</c:v>
                </c:pt>
                <c:pt idx="6">
                  <c:v>1.1241333545681369</c:v>
                </c:pt>
                <c:pt idx="7">
                  <c:v>1.1816849816849819</c:v>
                </c:pt>
                <c:pt idx="8">
                  <c:v>0.97728406858841599</c:v>
                </c:pt>
                <c:pt idx="9">
                  <c:v>1.19771725858682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52-4BEE-B043-BAE5A41378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644861968"/>
        <c:axId val="1609435856"/>
      </c:lineChart>
      <c:catAx>
        <c:axId val="1644861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9435856"/>
        <c:crosses val="autoZero"/>
        <c:auto val="1"/>
        <c:lblAlgn val="ctr"/>
        <c:lblOffset val="100"/>
        <c:noMultiLvlLbl val="0"/>
      </c:catAx>
      <c:valAx>
        <c:axId val="16094358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48619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420nm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All three sets'!$G$48:$G$49</c:f>
              <c:strCache>
                <c:ptCount val="2"/>
                <c:pt idx="0">
                  <c:v>420nm average</c:v>
                </c:pt>
                <c:pt idx="1">
                  <c:v>Positiv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G$64:$G$7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17841191245162</c:v>
                  </c:pt>
                  <c:pt idx="2">
                    <c:v>1.57595692988131E-2</c:v>
                  </c:pt>
                  <c:pt idx="3">
                    <c:v>4.76875307301294E-2</c:v>
                  </c:pt>
                  <c:pt idx="4">
                    <c:v>0.13289433452904201</c:v>
                  </c:pt>
                  <c:pt idx="5">
                    <c:v>0.34813346862070899</c:v>
                  </c:pt>
                  <c:pt idx="6">
                    <c:v>1.6369243855379909</c:v>
                  </c:pt>
                  <c:pt idx="7">
                    <c:v>0.75285322393590504</c:v>
                  </c:pt>
                  <c:pt idx="8">
                    <c:v>0.98141932451326397</c:v>
                  </c:pt>
                  <c:pt idx="9">
                    <c:v>0.51800201112141597</c:v>
                  </c:pt>
                </c:numCache>
              </c:numRef>
            </c:plus>
            <c:minus>
              <c:numRef>
                <c:f>'All three sets'!$G$64:$G$7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17841191245162</c:v>
                  </c:pt>
                  <c:pt idx="2">
                    <c:v>1.57595692988131E-2</c:v>
                  </c:pt>
                  <c:pt idx="3">
                    <c:v>4.76875307301294E-2</c:v>
                  </c:pt>
                  <c:pt idx="4">
                    <c:v>0.13289433452904201</c:v>
                  </c:pt>
                  <c:pt idx="5">
                    <c:v>0.34813346862070899</c:v>
                  </c:pt>
                  <c:pt idx="6">
                    <c:v>1.6369243855379909</c:v>
                  </c:pt>
                  <c:pt idx="7">
                    <c:v>0.75285322393590504</c:v>
                  </c:pt>
                  <c:pt idx="8">
                    <c:v>0.98141932451326397</c:v>
                  </c:pt>
                  <c:pt idx="9">
                    <c:v>0.518002011121415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F$50:$F$59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G$50:$G$59</c:f>
              <c:numCache>
                <c:formatCode>General</c:formatCode>
                <c:ptCount val="10"/>
                <c:pt idx="0">
                  <c:v>1</c:v>
                </c:pt>
                <c:pt idx="1">
                  <c:v>1.017316017316017</c:v>
                </c:pt>
                <c:pt idx="2">
                  <c:v>1.038952550717257</c:v>
                </c:pt>
                <c:pt idx="3">
                  <c:v>1.0986843222137339</c:v>
                </c:pt>
                <c:pt idx="4">
                  <c:v>2.8419319242848631</c:v>
                </c:pt>
                <c:pt idx="5">
                  <c:v>3.6415923945335709</c:v>
                </c:pt>
                <c:pt idx="6">
                  <c:v>4.6838553603259436</c:v>
                </c:pt>
                <c:pt idx="7">
                  <c:v>4.6545030133265399</c:v>
                </c:pt>
                <c:pt idx="8">
                  <c:v>5.1376198964434252</c:v>
                </c:pt>
                <c:pt idx="9">
                  <c:v>5.29506833036244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BA5-4145-B664-1F60FF1167F1}"/>
            </c:ext>
          </c:extLst>
        </c:ser>
        <c:ser>
          <c:idx val="1"/>
          <c:order val="1"/>
          <c:tx>
            <c:strRef>
              <c:f>'All three sets'!$H$48:$H$49</c:f>
              <c:strCache>
                <c:ptCount val="2"/>
                <c:pt idx="0">
                  <c:v>420nm average</c:v>
                </c:pt>
                <c:pt idx="1">
                  <c:v>negativ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H$64:$H$7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4919966253498701</c:v>
                  </c:pt>
                  <c:pt idx="2">
                    <c:v>0.135277706479561</c:v>
                  </c:pt>
                  <c:pt idx="3">
                    <c:v>0.107842741269006</c:v>
                  </c:pt>
                  <c:pt idx="4">
                    <c:v>9.6709034479482994E-2</c:v>
                  </c:pt>
                  <c:pt idx="5">
                    <c:v>0.43133529280262201</c:v>
                  </c:pt>
                  <c:pt idx="6">
                    <c:v>0.187295862421681</c:v>
                  </c:pt>
                  <c:pt idx="7">
                    <c:v>0.136398704927538</c:v>
                  </c:pt>
                  <c:pt idx="8">
                    <c:v>3.9758203419552302E-2</c:v>
                  </c:pt>
                  <c:pt idx="9">
                    <c:v>0.18057627080067801</c:v>
                  </c:pt>
                </c:numCache>
              </c:numRef>
            </c:plus>
            <c:minus>
              <c:numRef>
                <c:f>'All three sets'!$H$64:$H$7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4919966253498701</c:v>
                  </c:pt>
                  <c:pt idx="2">
                    <c:v>0.135277706479561</c:v>
                  </c:pt>
                  <c:pt idx="3">
                    <c:v>0.107842741269006</c:v>
                  </c:pt>
                  <c:pt idx="4">
                    <c:v>9.6709034479482994E-2</c:v>
                  </c:pt>
                  <c:pt idx="5">
                    <c:v>0.43133529280262201</c:v>
                  </c:pt>
                  <c:pt idx="6">
                    <c:v>0.187295862421681</c:v>
                  </c:pt>
                  <c:pt idx="7">
                    <c:v>0.136398704927538</c:v>
                  </c:pt>
                  <c:pt idx="8">
                    <c:v>3.9758203419552302E-2</c:v>
                  </c:pt>
                  <c:pt idx="9">
                    <c:v>0.180576270800678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F$50:$F$59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H$50:$H$59</c:f>
              <c:numCache>
                <c:formatCode>General</c:formatCode>
                <c:ptCount val="10"/>
                <c:pt idx="0">
                  <c:v>1</c:v>
                </c:pt>
                <c:pt idx="1">
                  <c:v>1.0299342105263161</c:v>
                </c:pt>
                <c:pt idx="2">
                  <c:v>1.1201388888888899</c:v>
                </c:pt>
                <c:pt idx="3">
                  <c:v>0.97576754385964903</c:v>
                </c:pt>
                <c:pt idx="4">
                  <c:v>1.0800438596491231</c:v>
                </c:pt>
                <c:pt idx="5">
                  <c:v>1.335343567251462</c:v>
                </c:pt>
                <c:pt idx="6">
                  <c:v>1.052156432748538</c:v>
                </c:pt>
                <c:pt idx="7">
                  <c:v>1.130811403508772</c:v>
                </c:pt>
                <c:pt idx="8">
                  <c:v>0.96326754385964897</c:v>
                </c:pt>
                <c:pt idx="9">
                  <c:v>1.14400584795321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BA5-4145-B664-1F60FF1167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694290096"/>
        <c:axId val="1694172816"/>
      </c:lineChart>
      <c:catAx>
        <c:axId val="169429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4172816"/>
        <c:crosses val="autoZero"/>
        <c:auto val="1"/>
        <c:lblAlgn val="ctr"/>
        <c:lblOffset val="100"/>
        <c:noMultiLvlLbl val="0"/>
      </c:catAx>
      <c:valAx>
        <c:axId val="1694172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4290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400nm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All three sets'!$G$94:$G$95</c:f>
              <c:strCache>
                <c:ptCount val="2"/>
                <c:pt idx="0">
                  <c:v>400nm</c:v>
                </c:pt>
                <c:pt idx="1">
                  <c:v>Positiv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G$110:$G$119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22461339352056</c:v>
                  </c:pt>
                  <c:pt idx="2">
                    <c:v>1.56097801963977E-2</c:v>
                  </c:pt>
                  <c:pt idx="3">
                    <c:v>7.4329649277401003E-2</c:v>
                  </c:pt>
                  <c:pt idx="4">
                    <c:v>3.8854280237500503E-2</c:v>
                  </c:pt>
                  <c:pt idx="5">
                    <c:v>0.36191287421359303</c:v>
                  </c:pt>
                  <c:pt idx="6">
                    <c:v>1.7346529466061751</c:v>
                  </c:pt>
                  <c:pt idx="7">
                    <c:v>0.730693711335063</c:v>
                  </c:pt>
                  <c:pt idx="8">
                    <c:v>1.096088504189612</c:v>
                  </c:pt>
                  <c:pt idx="9">
                    <c:v>0.56187714613323403</c:v>
                  </c:pt>
                </c:numCache>
              </c:numRef>
            </c:plus>
            <c:minus>
              <c:numRef>
                <c:f>'All three sets'!$G$110:$G$119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22461339352056</c:v>
                  </c:pt>
                  <c:pt idx="2">
                    <c:v>1.56097801963977E-2</c:v>
                  </c:pt>
                  <c:pt idx="3">
                    <c:v>7.4329649277401003E-2</c:v>
                  </c:pt>
                  <c:pt idx="4">
                    <c:v>3.8854280237500503E-2</c:v>
                  </c:pt>
                  <c:pt idx="5">
                    <c:v>0.36191287421359303</c:v>
                  </c:pt>
                  <c:pt idx="6">
                    <c:v>1.7346529466061751</c:v>
                  </c:pt>
                  <c:pt idx="7">
                    <c:v>0.730693711335063</c:v>
                  </c:pt>
                  <c:pt idx="8">
                    <c:v>1.096088504189612</c:v>
                  </c:pt>
                  <c:pt idx="9">
                    <c:v>0.561877146133234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F$96:$F$105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G$96:$G$105</c:f>
              <c:numCache>
                <c:formatCode>General</c:formatCode>
                <c:ptCount val="10"/>
                <c:pt idx="0">
                  <c:v>1</c:v>
                </c:pt>
                <c:pt idx="1">
                  <c:v>0.988791423001949</c:v>
                </c:pt>
                <c:pt idx="2">
                  <c:v>1.0360492071018399</c:v>
                </c:pt>
                <c:pt idx="3">
                  <c:v>1.0823455033981351</c:v>
                </c:pt>
                <c:pt idx="4">
                  <c:v>2.8202281228596999</c:v>
                </c:pt>
                <c:pt idx="5">
                  <c:v>3.5795005531847641</c:v>
                </c:pt>
                <c:pt idx="6">
                  <c:v>4.617867867867866</c:v>
                </c:pt>
                <c:pt idx="7">
                  <c:v>4.5380248669722336</c:v>
                </c:pt>
                <c:pt idx="8">
                  <c:v>5.0163452926610823</c:v>
                </c:pt>
                <c:pt idx="9">
                  <c:v>5.21554449186028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0B-4AD6-AFD4-2880980A4640}"/>
            </c:ext>
          </c:extLst>
        </c:ser>
        <c:ser>
          <c:idx val="1"/>
          <c:order val="1"/>
          <c:tx>
            <c:strRef>
              <c:f>'All three sets'!$H$94:$H$95</c:f>
              <c:strCache>
                <c:ptCount val="2"/>
                <c:pt idx="0">
                  <c:v>400nm</c:v>
                </c:pt>
                <c:pt idx="1">
                  <c:v>negativ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H$110:$H$119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6654249883097899</c:v>
                  </c:pt>
                  <c:pt idx="2">
                    <c:v>0.14147059875479701</c:v>
                  </c:pt>
                  <c:pt idx="3">
                    <c:v>0.13469555672141501</c:v>
                  </c:pt>
                  <c:pt idx="4">
                    <c:v>7.64087340069536E-3</c:v>
                  </c:pt>
                  <c:pt idx="5">
                    <c:v>0.48716245045680501</c:v>
                  </c:pt>
                  <c:pt idx="6">
                    <c:v>0.2180743730286</c:v>
                  </c:pt>
                  <c:pt idx="7">
                    <c:v>0.14575016852043099</c:v>
                  </c:pt>
                  <c:pt idx="8">
                    <c:v>5.5303327385098702E-2</c:v>
                  </c:pt>
                  <c:pt idx="9">
                    <c:v>0.22619086011030601</c:v>
                  </c:pt>
                </c:numCache>
              </c:numRef>
            </c:plus>
            <c:minus>
              <c:numRef>
                <c:f>'All three sets'!$H$110:$H$119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6654249883097899</c:v>
                  </c:pt>
                  <c:pt idx="2">
                    <c:v>0.14147059875479701</c:v>
                  </c:pt>
                  <c:pt idx="3">
                    <c:v>0.13469555672141501</c:v>
                  </c:pt>
                  <c:pt idx="4">
                    <c:v>7.64087340069536E-3</c:v>
                  </c:pt>
                  <c:pt idx="5">
                    <c:v>0.48716245045680501</c:v>
                  </c:pt>
                  <c:pt idx="6">
                    <c:v>0.2180743730286</c:v>
                  </c:pt>
                  <c:pt idx="7">
                    <c:v>0.14575016852043099</c:v>
                  </c:pt>
                  <c:pt idx="8">
                    <c:v>5.5303327385098702E-2</c:v>
                  </c:pt>
                  <c:pt idx="9">
                    <c:v>0.22619086011030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F$96:$F$105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H$96:$H$105</c:f>
              <c:numCache>
                <c:formatCode>General</c:formatCode>
                <c:ptCount val="10"/>
                <c:pt idx="0">
                  <c:v>1</c:v>
                </c:pt>
                <c:pt idx="1">
                  <c:v>1.0410759175465061</c:v>
                </c:pt>
                <c:pt idx="2">
                  <c:v>1.136701860231272</c:v>
                </c:pt>
                <c:pt idx="3">
                  <c:v>0.97958773252890896</c:v>
                </c:pt>
                <c:pt idx="4">
                  <c:v>1.09693313222725</c:v>
                </c:pt>
                <c:pt idx="5">
                  <c:v>1.4041729512317751</c:v>
                </c:pt>
                <c:pt idx="6">
                  <c:v>1.0854700854700849</c:v>
                </c:pt>
                <c:pt idx="7">
                  <c:v>1.167320261437909</c:v>
                </c:pt>
                <c:pt idx="8">
                  <c:v>0.97566616390145799</c:v>
                </c:pt>
                <c:pt idx="9">
                  <c:v>1.1652589240824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0B-4AD6-AFD4-2880980A46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43916272"/>
        <c:axId val="1443916800"/>
      </c:lineChart>
      <c:catAx>
        <c:axId val="1443916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3916800"/>
        <c:crosses val="autoZero"/>
        <c:auto val="1"/>
        <c:lblAlgn val="ctr"/>
        <c:lblOffset val="100"/>
        <c:noMultiLvlLbl val="0"/>
      </c:catAx>
      <c:valAx>
        <c:axId val="1443916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3916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380nm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All three sets'!$H$140:$H$141</c:f>
              <c:strCache>
                <c:ptCount val="2"/>
                <c:pt idx="0">
                  <c:v>380nm</c:v>
                </c:pt>
                <c:pt idx="1">
                  <c:v>Positiv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H$156:$H$165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6832275330537898E-2</c:v>
                  </c:pt>
                  <c:pt idx="2">
                    <c:v>2.6704452783989199E-4</c:v>
                  </c:pt>
                  <c:pt idx="3">
                    <c:v>9.7860798236605401E-2</c:v>
                  </c:pt>
                  <c:pt idx="4">
                    <c:v>5.4652213781354403E-2</c:v>
                  </c:pt>
                  <c:pt idx="5">
                    <c:v>0.32511955665019998</c:v>
                  </c:pt>
                  <c:pt idx="6">
                    <c:v>1.453559474223816</c:v>
                  </c:pt>
                  <c:pt idx="7">
                    <c:v>0.65695010927682496</c:v>
                  </c:pt>
                  <c:pt idx="8">
                    <c:v>0.94373823282798797</c:v>
                  </c:pt>
                  <c:pt idx="9">
                    <c:v>0.46503908798198401</c:v>
                  </c:pt>
                </c:numCache>
              </c:numRef>
            </c:plus>
            <c:minus>
              <c:numRef>
                <c:f>'All three sets'!$H$156:$H$165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6832275330537898E-2</c:v>
                  </c:pt>
                  <c:pt idx="2">
                    <c:v>2.6704452783989199E-4</c:v>
                  </c:pt>
                  <c:pt idx="3">
                    <c:v>9.7860798236605401E-2</c:v>
                  </c:pt>
                  <c:pt idx="4">
                    <c:v>5.4652213781354403E-2</c:v>
                  </c:pt>
                  <c:pt idx="5">
                    <c:v>0.32511955665019998</c:v>
                  </c:pt>
                  <c:pt idx="6">
                    <c:v>1.453559474223816</c:v>
                  </c:pt>
                  <c:pt idx="7">
                    <c:v>0.65695010927682496</c:v>
                  </c:pt>
                  <c:pt idx="8">
                    <c:v>0.94373823282798797</c:v>
                  </c:pt>
                  <c:pt idx="9">
                    <c:v>0.465039087981984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G$142:$G$151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H$142:$H$151</c:f>
              <c:numCache>
                <c:formatCode>General</c:formatCode>
                <c:ptCount val="10"/>
                <c:pt idx="0">
                  <c:v>1</c:v>
                </c:pt>
                <c:pt idx="1">
                  <c:v>1.0064754856614251</c:v>
                </c:pt>
                <c:pt idx="2">
                  <c:v>1.021430773974715</c:v>
                </c:pt>
                <c:pt idx="3">
                  <c:v>1.072155411655874</c:v>
                </c:pt>
                <c:pt idx="4">
                  <c:v>2.5072463768115938</c:v>
                </c:pt>
                <c:pt idx="5">
                  <c:v>3.133055812519272</c:v>
                </c:pt>
                <c:pt idx="6">
                  <c:v>3.997687326549491</c:v>
                </c:pt>
                <c:pt idx="7">
                  <c:v>3.9517422139993821</c:v>
                </c:pt>
                <c:pt idx="8">
                  <c:v>4.3077397471477008</c:v>
                </c:pt>
                <c:pt idx="9">
                  <c:v>4.42476102374344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BD3-403B-934F-5DEA0B5E8FB7}"/>
            </c:ext>
          </c:extLst>
        </c:ser>
        <c:ser>
          <c:idx val="1"/>
          <c:order val="1"/>
          <c:tx>
            <c:strRef>
              <c:f>'All three sets'!$I$140:$I$141</c:f>
              <c:strCache>
                <c:ptCount val="2"/>
                <c:pt idx="0">
                  <c:v>380nm</c:v>
                </c:pt>
                <c:pt idx="1">
                  <c:v>negativ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ll three sets'!$I$156:$I$165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9008767936864601</c:v>
                  </c:pt>
                  <c:pt idx="2">
                    <c:v>0.18129229809115999</c:v>
                  </c:pt>
                  <c:pt idx="3">
                    <c:v>0.14272276523139499</c:v>
                  </c:pt>
                  <c:pt idx="4">
                    <c:v>4.7694512883415301E-2</c:v>
                  </c:pt>
                  <c:pt idx="5">
                    <c:v>0.51025849956220404</c:v>
                  </c:pt>
                  <c:pt idx="6">
                    <c:v>0.30469225497576202</c:v>
                  </c:pt>
                  <c:pt idx="7">
                    <c:v>0.21232057994871201</c:v>
                  </c:pt>
                  <c:pt idx="8">
                    <c:v>0.110388353751117</c:v>
                  </c:pt>
                  <c:pt idx="9">
                    <c:v>0.302533513966877</c:v>
                  </c:pt>
                </c:numCache>
              </c:numRef>
            </c:plus>
            <c:minus>
              <c:numRef>
                <c:f>'All three sets'!$I$156:$I$165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9008767936864601</c:v>
                  </c:pt>
                  <c:pt idx="2">
                    <c:v>0.18129229809115999</c:v>
                  </c:pt>
                  <c:pt idx="3">
                    <c:v>0.14272276523139499</c:v>
                  </c:pt>
                  <c:pt idx="4">
                    <c:v>4.7694512883415301E-2</c:v>
                  </c:pt>
                  <c:pt idx="5">
                    <c:v>0.51025849956220404</c:v>
                  </c:pt>
                  <c:pt idx="6">
                    <c:v>0.30469225497576202</c:v>
                  </c:pt>
                  <c:pt idx="7">
                    <c:v>0.21232057994871201</c:v>
                  </c:pt>
                  <c:pt idx="8">
                    <c:v>0.110388353751117</c:v>
                  </c:pt>
                  <c:pt idx="9">
                    <c:v>0.3025335139668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ll three sets'!$G$142:$G$151</c:f>
              <c:strCache>
                <c:ptCount val="10"/>
                <c:pt idx="0">
                  <c:v>0min</c:v>
                </c:pt>
                <c:pt idx="1">
                  <c:v>5min</c:v>
                </c:pt>
                <c:pt idx="2">
                  <c:v>10min</c:v>
                </c:pt>
                <c:pt idx="3">
                  <c:v>15min</c:v>
                </c:pt>
                <c:pt idx="4">
                  <c:v>20min</c:v>
                </c:pt>
                <c:pt idx="5">
                  <c:v>25min</c:v>
                </c:pt>
                <c:pt idx="6">
                  <c:v>30min</c:v>
                </c:pt>
                <c:pt idx="7">
                  <c:v>35min</c:v>
                </c:pt>
                <c:pt idx="8">
                  <c:v>40min</c:v>
                </c:pt>
                <c:pt idx="9">
                  <c:v>45min</c:v>
                </c:pt>
              </c:strCache>
            </c:strRef>
          </c:cat>
          <c:val>
            <c:numRef>
              <c:f>'All three sets'!$I$142:$I$151</c:f>
              <c:numCache>
                <c:formatCode>General</c:formatCode>
                <c:ptCount val="10"/>
                <c:pt idx="0">
                  <c:v>1</c:v>
                </c:pt>
                <c:pt idx="1">
                  <c:v>1.0460647514819881</c:v>
                </c:pt>
                <c:pt idx="2">
                  <c:v>1.11450980392157</c:v>
                </c:pt>
                <c:pt idx="3">
                  <c:v>0.98359325125399</c:v>
                </c:pt>
                <c:pt idx="4">
                  <c:v>1.092275421796626</c:v>
                </c:pt>
                <c:pt idx="5">
                  <c:v>1.3822891016871861</c:v>
                </c:pt>
                <c:pt idx="6">
                  <c:v>1.1235294117647061</c:v>
                </c:pt>
                <c:pt idx="7">
                  <c:v>1.18388508891929</c:v>
                </c:pt>
                <c:pt idx="8">
                  <c:v>0.99813041495667998</c:v>
                </c:pt>
                <c:pt idx="9">
                  <c:v>1.19523027815777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BD3-403B-934F-5DEA0B5E8F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44380592"/>
        <c:axId val="1444382912"/>
      </c:lineChart>
      <c:catAx>
        <c:axId val="1444380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4382912"/>
        <c:crosses val="autoZero"/>
        <c:auto val="1"/>
        <c:lblAlgn val="ctr"/>
        <c:lblOffset val="100"/>
        <c:noMultiLvlLbl val="0"/>
      </c:catAx>
      <c:valAx>
        <c:axId val="1444382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43805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1467CB-40B3-C246-B1D0-267DE95A6622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037F5B-C2D1-484B-A86A-637D3C5536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5278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760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034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944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443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55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95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779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37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759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327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530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9AA67-0012-40BB-A54B-42CBF45A10C1}" type="datetimeFigureOut">
              <a:rPr lang="en-US" smtClean="0"/>
              <a:t>10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08579-3A58-44CF-97F9-2613B07A4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219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13" Type="http://schemas.openxmlformats.org/officeDocument/2006/relationships/image" Target="../media/image23.jpeg"/><Relationship Id="rId3" Type="http://schemas.openxmlformats.org/officeDocument/2006/relationships/image" Target="../media/image14.jpeg"/><Relationship Id="rId7" Type="http://schemas.openxmlformats.org/officeDocument/2006/relationships/image" Target="../media/image17.jpeg"/><Relationship Id="rId12" Type="http://schemas.openxmlformats.org/officeDocument/2006/relationships/image" Target="../media/image22.jpeg"/><Relationship Id="rId2" Type="http://schemas.openxmlformats.org/officeDocument/2006/relationships/image" Target="../media/image13.jpeg"/><Relationship Id="rId16" Type="http://schemas.openxmlformats.org/officeDocument/2006/relationships/image" Target="../media/image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11" Type="http://schemas.openxmlformats.org/officeDocument/2006/relationships/image" Target="../media/image21.jpeg"/><Relationship Id="rId5" Type="http://schemas.openxmlformats.org/officeDocument/2006/relationships/image" Target="../media/image15.jpeg"/><Relationship Id="rId15" Type="http://schemas.openxmlformats.org/officeDocument/2006/relationships/image" Target="../media/image25.jpeg"/><Relationship Id="rId10" Type="http://schemas.openxmlformats.org/officeDocument/2006/relationships/image" Target="../media/image20.jpeg"/><Relationship Id="rId4" Type="http://schemas.openxmlformats.org/officeDocument/2006/relationships/image" Target="../media/image3.jpeg"/><Relationship Id="rId9" Type="http://schemas.openxmlformats.org/officeDocument/2006/relationships/image" Target="../media/image19.jpeg"/><Relationship Id="rId14" Type="http://schemas.openxmlformats.org/officeDocument/2006/relationships/image" Target="../media/image24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0882973"/>
              </p:ext>
            </p:extLst>
          </p:nvPr>
        </p:nvGraphicFramePr>
        <p:xfrm>
          <a:off x="1193800" y="9416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131466"/>
              </p:ext>
            </p:extLst>
          </p:nvPr>
        </p:nvGraphicFramePr>
        <p:xfrm>
          <a:off x="6375400" y="9416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0645821"/>
              </p:ext>
            </p:extLst>
          </p:nvPr>
        </p:nvGraphicFramePr>
        <p:xfrm>
          <a:off x="1193800" y="39642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1192584"/>
              </p:ext>
            </p:extLst>
          </p:nvPr>
        </p:nvGraphicFramePr>
        <p:xfrm>
          <a:off x="6375400" y="39642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45440" y="325120"/>
            <a:ext cx="499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ure 1: EBT Spectrophotometric analysi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2498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32984" y="1128493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 min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824822" y="1172086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  <a:r>
              <a:rPr lang="en-US" dirty="0" smtClean="0"/>
              <a:t> mi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207993" y="1174951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 m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544327" y="1208511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5 min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792832" y="1227337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0 min</a:t>
            </a:r>
            <a:endParaRPr lang="en-US" dirty="0"/>
          </a:p>
        </p:txBody>
      </p:sp>
      <p:pic>
        <p:nvPicPr>
          <p:cNvPr id="11" name="Picture 10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86" t="26326" r="34470" b="34469"/>
          <a:stretch/>
        </p:blipFill>
        <p:spPr>
          <a:xfrm>
            <a:off x="2218550" y="1596669"/>
            <a:ext cx="1195211" cy="977900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26" t="17802" r="23358" b="20266"/>
          <a:stretch/>
        </p:blipFill>
        <p:spPr>
          <a:xfrm>
            <a:off x="2218549" y="2604627"/>
            <a:ext cx="1191019" cy="1001191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67" t="5113" r="74180" b="81629"/>
          <a:stretch/>
        </p:blipFill>
        <p:spPr>
          <a:xfrm>
            <a:off x="2214059" y="3635876"/>
            <a:ext cx="1199701" cy="925013"/>
          </a:xfrm>
          <a:prstGeom prst="rect">
            <a:avLst/>
          </a:prstGeom>
          <a:effectLst>
            <a:outerShdw dist="50800" dir="5400000" algn="ctr" rotWithShape="0">
              <a:srgbClr val="000000">
                <a:alpha val="43137"/>
              </a:srgbClr>
            </a:outerShdw>
          </a:effectLst>
        </p:spPr>
      </p:pic>
      <p:pic>
        <p:nvPicPr>
          <p:cNvPr id="14" name="Picture 13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5" t="19358" r="73834" b="68223"/>
          <a:stretch/>
        </p:blipFill>
        <p:spPr>
          <a:xfrm>
            <a:off x="3626431" y="3712820"/>
            <a:ext cx="1080089" cy="914449"/>
          </a:xfrm>
          <a:prstGeom prst="rect">
            <a:avLst/>
          </a:prstGeom>
        </p:spPr>
      </p:pic>
      <p:pic>
        <p:nvPicPr>
          <p:cNvPr id="16" name="Picture 15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34" t="33563" r="73854" b="53531"/>
          <a:stretch/>
        </p:blipFill>
        <p:spPr>
          <a:xfrm>
            <a:off x="4961364" y="3687384"/>
            <a:ext cx="1197563" cy="914449"/>
          </a:xfrm>
          <a:prstGeom prst="rect">
            <a:avLst/>
          </a:prstGeom>
        </p:spPr>
      </p:pic>
      <p:pic>
        <p:nvPicPr>
          <p:cNvPr id="17" name="Picture 16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24" t="47721" r="73926" b="39129"/>
          <a:stretch/>
        </p:blipFill>
        <p:spPr>
          <a:xfrm>
            <a:off x="6391395" y="3681590"/>
            <a:ext cx="1062205" cy="920243"/>
          </a:xfrm>
          <a:prstGeom prst="rect">
            <a:avLst/>
          </a:prstGeom>
        </p:spPr>
      </p:pic>
      <p:pic>
        <p:nvPicPr>
          <p:cNvPr id="18" name="Picture 17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09" t="63312" r="73954" b="23782"/>
          <a:stretch/>
        </p:blipFill>
        <p:spPr>
          <a:xfrm>
            <a:off x="7635904" y="3763838"/>
            <a:ext cx="1167394" cy="863431"/>
          </a:xfrm>
          <a:prstGeom prst="rect">
            <a:avLst/>
          </a:prstGeom>
        </p:spPr>
      </p:pic>
      <p:pic>
        <p:nvPicPr>
          <p:cNvPr id="28" name="Picture 27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11" t="25324" r="35444" b="34984"/>
          <a:stretch/>
        </p:blipFill>
        <p:spPr>
          <a:xfrm>
            <a:off x="3626431" y="1596669"/>
            <a:ext cx="1094199" cy="949107"/>
          </a:xfrm>
          <a:prstGeom prst="rect">
            <a:avLst/>
          </a:prstGeom>
        </p:spPr>
      </p:pic>
      <p:pic>
        <p:nvPicPr>
          <p:cNvPr id="29" name="Picture 28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63" t="26364" r="35993" b="38083"/>
          <a:stretch/>
        </p:blipFill>
        <p:spPr>
          <a:xfrm>
            <a:off x="4961364" y="1624786"/>
            <a:ext cx="1197563" cy="920990"/>
          </a:xfrm>
          <a:prstGeom prst="rect">
            <a:avLst/>
          </a:prstGeom>
        </p:spPr>
      </p:pic>
      <p:pic>
        <p:nvPicPr>
          <p:cNvPr id="30" name="Picture 29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09" t="24107" r="35931" b="37906"/>
          <a:stretch/>
        </p:blipFill>
        <p:spPr>
          <a:xfrm>
            <a:off x="6399661" y="1664908"/>
            <a:ext cx="1019469" cy="882727"/>
          </a:xfrm>
          <a:prstGeom prst="rect">
            <a:avLst/>
          </a:prstGeom>
        </p:spPr>
      </p:pic>
      <p:pic>
        <p:nvPicPr>
          <p:cNvPr id="31" name="Picture 30"/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67" t="29849" r="36712" b="33138"/>
          <a:stretch/>
        </p:blipFill>
        <p:spPr>
          <a:xfrm>
            <a:off x="7632565" y="1693025"/>
            <a:ext cx="1170734" cy="852751"/>
          </a:xfrm>
          <a:prstGeom prst="rect">
            <a:avLst/>
          </a:prstGeom>
        </p:spPr>
      </p:pic>
      <p:pic>
        <p:nvPicPr>
          <p:cNvPr id="38" name="Picture 37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8" t="19968" r="26191" b="18182"/>
          <a:stretch/>
        </p:blipFill>
        <p:spPr>
          <a:xfrm>
            <a:off x="3626431" y="2650223"/>
            <a:ext cx="1080090" cy="958150"/>
          </a:xfrm>
          <a:prstGeom prst="rect">
            <a:avLst/>
          </a:prstGeom>
        </p:spPr>
      </p:pic>
      <p:pic>
        <p:nvPicPr>
          <p:cNvPr id="39" name="Picture 38"/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12" t="16315" r="30087" b="22321"/>
          <a:stretch/>
        </p:blipFill>
        <p:spPr>
          <a:xfrm>
            <a:off x="4961364" y="2625206"/>
            <a:ext cx="1197563" cy="957731"/>
          </a:xfrm>
          <a:prstGeom prst="rect">
            <a:avLst/>
          </a:prstGeom>
        </p:spPr>
      </p:pic>
      <p:pic>
        <p:nvPicPr>
          <p:cNvPr id="40" name="Picture 39"/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46" t="19480" r="26840" b="21835"/>
          <a:stretch/>
        </p:blipFill>
        <p:spPr>
          <a:xfrm>
            <a:off x="6400127" y="2670705"/>
            <a:ext cx="1019003" cy="939528"/>
          </a:xfrm>
          <a:prstGeom prst="rect">
            <a:avLst/>
          </a:prstGeom>
        </p:spPr>
      </p:pic>
      <p:pic>
        <p:nvPicPr>
          <p:cNvPr id="41" name="Picture 40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23" t="15382" r="25125" b="23985"/>
          <a:stretch/>
        </p:blipFill>
        <p:spPr>
          <a:xfrm>
            <a:off x="7613045" y="2693027"/>
            <a:ext cx="1190253" cy="912792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1404264" y="1910457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t 1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1404264" y="2873844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t 2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1404264" y="3918873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t 3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2669876" y="5027193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1976466" y="5018309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3967222" y="4991688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 rot="16200000">
            <a:off x="3369345" y="5023748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5383990" y="4975357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4725215" y="5007418"/>
            <a:ext cx="98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6747226" y="4991688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6152648" y="5027193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8107723" y="4975357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7395414" y="4995133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64" name="TextBox 63"/>
          <p:cNvSpPr txBox="1"/>
          <p:nvPr/>
        </p:nvSpPr>
        <p:spPr>
          <a:xfrm>
            <a:off x="4736126" y="257537"/>
            <a:ext cx="31615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/>
              <a:t>EBT dye 0-20 min 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16159975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08" t="53233" r="36380" b="33130"/>
          <a:stretch/>
        </p:blipFill>
        <p:spPr>
          <a:xfrm>
            <a:off x="9124943" y="3554086"/>
            <a:ext cx="1162727" cy="87990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554605" y="874624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5 mi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051121" y="866504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0 mi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019660" y="864232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5 min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581676" y="864232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40 mi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9290967" y="843328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45 min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91" t="78346" r="73795" b="8748"/>
          <a:stretch/>
        </p:blipFill>
        <p:spPr>
          <a:xfrm>
            <a:off x="2297392" y="3546984"/>
            <a:ext cx="1202489" cy="86124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33" t="9213" r="36092" b="78368"/>
          <a:stretch/>
        </p:blipFill>
        <p:spPr>
          <a:xfrm>
            <a:off x="3766484" y="3554086"/>
            <a:ext cx="1269540" cy="86328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65" t="22606" r="36746" b="63758"/>
          <a:stretch/>
        </p:blipFill>
        <p:spPr>
          <a:xfrm>
            <a:off x="5797570" y="3546984"/>
            <a:ext cx="1107313" cy="86124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95" t="38677" r="36416" b="48174"/>
          <a:stretch/>
        </p:blipFill>
        <p:spPr>
          <a:xfrm>
            <a:off x="7432891" y="3546574"/>
            <a:ext cx="1164766" cy="87357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37" t="28734" r="32035" b="33766"/>
          <a:stretch/>
        </p:blipFill>
        <p:spPr>
          <a:xfrm>
            <a:off x="2312336" y="1350853"/>
            <a:ext cx="1205430" cy="88821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01" t="27057" r="32797" b="36904"/>
          <a:stretch/>
        </p:blipFill>
        <p:spPr>
          <a:xfrm>
            <a:off x="3785270" y="1340880"/>
            <a:ext cx="1363326" cy="90480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90" t="26786" r="34632" b="37419"/>
          <a:stretch/>
        </p:blipFill>
        <p:spPr>
          <a:xfrm>
            <a:off x="5770000" y="1324551"/>
            <a:ext cx="1275260" cy="88010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38" t="27759" r="33820" b="34254"/>
          <a:stretch/>
        </p:blipFill>
        <p:spPr>
          <a:xfrm>
            <a:off x="7432891" y="1340880"/>
            <a:ext cx="1164766" cy="88205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16" t="31786" r="33412" b="28571"/>
          <a:stretch/>
        </p:blipFill>
        <p:spPr>
          <a:xfrm>
            <a:off x="9128068" y="1309396"/>
            <a:ext cx="1156476" cy="910417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67" t="17079" r="29779" b="15713"/>
          <a:stretch/>
        </p:blipFill>
        <p:spPr>
          <a:xfrm>
            <a:off x="2300401" y="2313607"/>
            <a:ext cx="1209219" cy="115883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26" t="1217" r="20834" b="35714"/>
          <a:stretch/>
        </p:blipFill>
        <p:spPr>
          <a:xfrm>
            <a:off x="3766484" y="2327333"/>
            <a:ext cx="1627026" cy="1145108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25" t="17533" r="28625" b="16964"/>
          <a:stretch/>
        </p:blipFill>
        <p:spPr>
          <a:xfrm>
            <a:off x="5789695" y="2313607"/>
            <a:ext cx="1344074" cy="115883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55" t="20211" r="27652" b="12582"/>
          <a:stretch/>
        </p:blipFill>
        <p:spPr>
          <a:xfrm>
            <a:off x="7398787" y="2313607"/>
            <a:ext cx="1461138" cy="1158834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0" t="16558" r="25054" b="21834"/>
          <a:stretch/>
        </p:blipFill>
        <p:spPr>
          <a:xfrm>
            <a:off x="9124943" y="2313607"/>
            <a:ext cx="1520684" cy="1158834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540330" y="1752595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t 1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1540330" y="2715982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t 2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1540330" y="3761011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t 3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2726250" y="4800957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2073784" y="4833017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287781" y="4806396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3567075" y="4838456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6214557" y="4790067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5603035" y="4822127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7893723" y="4806396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7241257" y="4838456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9520491" y="4792748"/>
            <a:ext cx="91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8949910" y="4838456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gative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5159241" y="191266"/>
            <a:ext cx="336989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/>
              <a:t>EBT dye 25-45 min 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27055471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1016000"/>
            <a:ext cx="91033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1: </a:t>
            </a:r>
            <a:r>
              <a:rPr lang="en-US" dirty="0" smtClean="0"/>
              <a:t>EBT </a:t>
            </a:r>
            <a:r>
              <a:rPr lang="en-US" dirty="0"/>
              <a:t>c</a:t>
            </a:r>
            <a:r>
              <a:rPr lang="en-US" dirty="0" smtClean="0"/>
              <a:t>olor change and spectrophotometric analysis. Positive and negative control samples containing S. aureus purified DNA are quantified using Spectrophotometric analysis at 475, 420, 400 and 380 nm absorbance at 5 minute time intervals from 0-45 min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6192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E92DD200099084EAEF242F13933C48E" ma:contentTypeVersion="7" ma:contentTypeDescription="Create a new document." ma:contentTypeScope="" ma:versionID="2d913875ce4670ef9b7de9581d354d6a">
  <xsd:schema xmlns:xsd="http://www.w3.org/2001/XMLSchema" xmlns:p="http://schemas.microsoft.com/office/2006/metadata/properties" xmlns:ns2="018c3ce0-25d7-4964-8f5f-0766fc370baa" targetNamespace="http://schemas.microsoft.com/office/2006/metadata/properties" ma:root="true" ma:fieldsID="5b048e0c7ee6cc25658af98c0a1f5fda" ns2:_="">
    <xsd:import namespace="018c3ce0-25d7-4964-8f5f-0766fc370b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18c3ce0-25d7-4964-8f5f-0766fc370b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018c3ce0-25d7-4964-8f5f-0766fc370baa">false</IsDeleted>
    <TitleName xmlns="018c3ce0-25d7-4964-8f5f-0766fc370baa">Presentation 1.PPTX</TitleName>
    <DocumentType xmlns="018c3ce0-25d7-4964-8f5f-0766fc370baa">Presentation</DocumentType>
    <DocumentId xmlns="018c3ce0-25d7-4964-8f5f-0766fc370baa">Presentation 1.PPTX</DocumentId>
    <FileFormat xmlns="018c3ce0-25d7-4964-8f5f-0766fc370baa">PPTX</FileFormat>
    <StageName xmlns="018c3ce0-25d7-4964-8f5f-0766fc370baa" xsi:nil="true"/>
    <Checked_x0020_Out_x0020_To xmlns="018c3ce0-25d7-4964-8f5f-0766fc370baa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2AFD0F39-6B98-40A6-B997-4EFAE33BBFD4}"/>
</file>

<file path=customXml/itemProps2.xml><?xml version="1.0" encoding="utf-8"?>
<ds:datastoreItem xmlns:ds="http://schemas.openxmlformats.org/officeDocument/2006/customXml" ds:itemID="{18859E67-4A83-4CC1-A779-1E960FC6AF49}"/>
</file>

<file path=customXml/itemProps3.xml><?xml version="1.0" encoding="utf-8"?>
<ds:datastoreItem xmlns:ds="http://schemas.openxmlformats.org/officeDocument/2006/customXml" ds:itemID="{582B3474-CDEF-48E7-A666-DB8E3EB84AA1}"/>
</file>

<file path=docProps/app.xml><?xml version="1.0" encoding="utf-8"?>
<Properties xmlns="http://schemas.openxmlformats.org/officeDocument/2006/extended-properties" xmlns:vt="http://schemas.openxmlformats.org/officeDocument/2006/docPropsVTypes">
  <TotalTime>810</TotalTime>
  <Words>118</Words>
  <Application>Microsoft Office PowerPoint</Application>
  <PresentationFormat>Widescreen</PresentationFormat>
  <Paragraphs>4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ichigan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enggang Li</dc:creator>
  <cp:lastModifiedBy>Brett Etchebarne</cp:lastModifiedBy>
  <cp:revision>18</cp:revision>
  <dcterms:created xsi:type="dcterms:W3CDTF">2017-09-13T18:31:12Z</dcterms:created>
  <dcterms:modified xsi:type="dcterms:W3CDTF">2017-10-20T13:44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E92DD200099084EAEF242F13933C48E</vt:lpwstr>
  </property>
</Properties>
</file>